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8ECAB-4696-4967-9657-46BB8381B6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E3493-C863-44FD-98C3-7EC7392BB7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E77C0-3CF9-42E2-B23E-CA8BF85CBF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BC8EF8-2EC6-4293-8DD1-84091DD3A4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7A740-255D-4FA9-A580-873D73E593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BF588-3B4B-457A-8BC6-51C8D3B5D1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CC6C0-692E-4F69-BB05-3DED7474DA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74C7A-D9C2-41E7-BFC2-E69F4F9199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58CB50-7E19-49DE-B124-9634D35C82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254C5-D50E-430D-B0B8-E09D7E7A63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1BCE3-6ECB-451C-B71B-0A4B039462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54DD4-C133-4910-A530-3D2B07FDA8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575014-F113-4739-BF51-3C5930B9967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50920" y="260280"/>
            <a:ext cx="8496360" cy="6091920"/>
            <a:chOff x="250920" y="260280"/>
            <a:chExt cx="8496360" cy="6091920"/>
          </a:xfrm>
        </p:grpSpPr>
        <p:sp>
          <p:nvSpPr>
            <p:cNvPr id="42" name="Rectangle 2"/>
            <p:cNvSpPr/>
            <p:nvPr/>
          </p:nvSpPr>
          <p:spPr>
            <a:xfrm>
              <a:off x="250920" y="260280"/>
              <a:ext cx="8496360" cy="777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Arial"/>
                </a:rPr>
                <a:t>Table 1. 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Initial and final biomass  concentrations and the amount of acid/base added</a:t>
              </a:r>
              <a:br>
                <a:rPr sz="1600"/>
              </a:b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320"/>
            <p:cNvSpPr/>
            <p:nvPr/>
          </p:nvSpPr>
          <p:spPr>
            <a:xfrm>
              <a:off x="322200" y="6014880"/>
              <a:ext cx="1695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uplicate   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iplic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95280" y="1066680"/>
              <a:ext cx="2201760" cy="1389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451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597040" y="1066680"/>
              <a:ext cx="251136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Biomass Concentra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108400" y="1066680"/>
              <a:ext cx="353556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ton Production/ Consumption Calculation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597040" y="1676520"/>
              <a:ext cx="1322640" cy="77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CA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ime (h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919680" y="1676520"/>
              <a:ext cx="1188720" cy="77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O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108400" y="1676520"/>
              <a:ext cx="1812960" cy="77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tons (milli equivalent)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921360" y="1676520"/>
              <a:ext cx="1722600" cy="77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etate / Glucose (mM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95280" y="2455920"/>
              <a:ext cx="220176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 fontScale="99000"/>
            </a:bodyPr>
            <a:p>
              <a:pPr>
                <a:spcBef>
                  <a:spcPts val="400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E. coli –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lucose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iti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n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597040" y="2455920"/>
              <a:ext cx="132264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919680" y="2455920"/>
              <a:ext cx="118872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6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108400" y="2455920"/>
              <a:ext cx="181296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.9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921360" y="2455920"/>
              <a:ext cx="172260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.9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.8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95280" y="3278160"/>
              <a:ext cx="220176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 fontScale="99000"/>
            </a:bodyPr>
            <a:p>
              <a:pPr>
                <a:spcBef>
                  <a:spcPts val="400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E. coli –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etate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iti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n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597040" y="3278160"/>
              <a:ext cx="132264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919680" y="3278160"/>
              <a:ext cx="118872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108400" y="3278160"/>
              <a:ext cx="181296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3.5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921360" y="3278160"/>
              <a:ext cx="1722600" cy="82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6.2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7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95280" y="4100400"/>
              <a:ext cx="2201760" cy="84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spcBef>
                  <a:spcPts val="400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. sulfurreducens</a:t>
              </a:r>
              <a:r>
                <a:rPr b="0" i="1" lang="en-US" sz="16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iti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n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597040" y="4100400"/>
              <a:ext cx="1322640" cy="84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3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919680" y="4100400"/>
              <a:ext cx="1188720" cy="84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3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108400" y="4100400"/>
              <a:ext cx="1812960" cy="84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3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6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921360" y="4100400"/>
              <a:ext cx="1722600" cy="84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.6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.8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95280" y="4941720"/>
              <a:ext cx="2201760" cy="107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spcBef>
                  <a:spcPts val="400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. metallireducens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iti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n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597040" y="4941720"/>
              <a:ext cx="1322640" cy="107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919680" y="4941720"/>
              <a:ext cx="1188720" cy="107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108400" y="4941720"/>
              <a:ext cx="1812960" cy="107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.7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6921360" y="4941720"/>
              <a:ext cx="1722600" cy="107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.7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349"/>
                </a:spcBef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9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597040" y="1066680"/>
              <a:ext cx="0" cy="4945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919680" y="1676520"/>
              <a:ext cx="0" cy="4335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108400" y="1066680"/>
              <a:ext cx="0" cy="4945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6921360" y="1676520"/>
              <a:ext cx="0" cy="4335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597040" y="1676520"/>
              <a:ext cx="6046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95280" y="2455920"/>
              <a:ext cx="8248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95280" y="3278160"/>
              <a:ext cx="8248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95280" y="4100400"/>
              <a:ext cx="8248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95280" y="4941720"/>
              <a:ext cx="8248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95280" y="1066680"/>
              <a:ext cx="0" cy="49453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8643960" y="1066680"/>
              <a:ext cx="0" cy="49453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95280" y="1066680"/>
              <a:ext cx="8248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95280" y="6012000"/>
              <a:ext cx="8248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4T01:04:44Z</dcterms:created>
  <dc:creator>Karthik</dc:creator>
  <dc:description/>
  <dc:language>en-US</dc:language>
  <cp:lastModifiedBy>User</cp:lastModifiedBy>
  <dcterms:modified xsi:type="dcterms:W3CDTF">2010-01-16T07:58:44Z</dcterms:modified>
  <cp:revision>74</cp:revision>
  <dc:subject/>
  <dc:title>Slide 1</dc:title>
</cp:coreProperties>
</file>